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1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3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016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251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01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533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545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955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6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099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021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616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982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E3C45-6383-49D0-A5E8-AD1BFEA50339}" type="datetimeFigureOut">
              <a:rPr lang="en-US" smtClean="0"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0EDAB-A7A2-40DA-A1ED-3E332B566B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099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8448" y="708608"/>
            <a:ext cx="4082754" cy="4064364"/>
          </a:xfrm>
          <a:prstGeom prst="rect">
            <a:avLst/>
          </a:prstGeom>
        </p:spPr>
      </p:pic>
      <p:sp>
        <p:nvSpPr>
          <p:cNvPr id="9" name="标题 1"/>
          <p:cNvSpPr txBox="1">
            <a:spLocks/>
          </p:cNvSpPr>
          <p:nvPr/>
        </p:nvSpPr>
        <p:spPr>
          <a:xfrm>
            <a:off x="776252" y="4874198"/>
            <a:ext cx="7614215" cy="137420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ctr" defTabSz="914400" rtl="0" eaLnBrk="1" latinLnBrk="0" hangingPunct="1">
              <a:spcBef>
                <a:spcPct val="0"/>
              </a:spcBef>
              <a:buFont typeface="Arial" pitchFamily="34" charset="0"/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20000"/>
              </a:lnSpc>
              <a:spcAft>
                <a:spcPts val="300"/>
              </a:spcAft>
              <a:defRPr/>
            </a:pP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. S1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hylogenetic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nalysis of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 with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LK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genes selected from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ther species. </a:t>
            </a:r>
          </a:p>
          <a:p>
            <a:pPr marL="0" indent="0" algn="just">
              <a:lnSpc>
                <a:spcPct val="120000"/>
              </a:lnSpc>
              <a:spcAft>
                <a:spcPts val="300"/>
              </a:spcAft>
              <a:defRPr/>
            </a:pP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</a:rPr>
              <a:t>The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phylogenetic tree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of the </a:t>
            </a:r>
            <a:r>
              <a:rPr lang="en-US" sz="1200" i="1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PgRLK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was constructed using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the ClustalX2 2.1 software (Larkin et al. 2007) with the neighbor-joining method (Saitou and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Nei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1987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). The number for each branch is for its bootstrap confidence from 10,000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bootstrap replications.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t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rabidopsis thaliana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ativa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l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olanum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c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aucus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rota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t, Solanum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uberosum</a:t>
            </a:r>
            <a:r>
              <a:rPr lang="en-US" altLang="zh-CN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he eight types of the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amily are indicated by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ifferent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olors, LRR type, yellow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l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ype, light green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S type, lime green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zh-CN" sz="120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ysM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ype, red;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ys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ype, purple; PERK type, cyan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pro type, fuchsia;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ec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ype, blue. </a:t>
            </a:r>
            <a:endParaRPr lang="en-US" altLang="zh-C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476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4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宋体</vt:lpstr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bin Zhang</dc:creator>
  <cp:lastModifiedBy>Meiping Zhang</cp:lastModifiedBy>
  <cp:revision>8</cp:revision>
  <dcterms:created xsi:type="dcterms:W3CDTF">2017-12-16T22:56:20Z</dcterms:created>
  <dcterms:modified xsi:type="dcterms:W3CDTF">2018-01-25T00:41:37Z</dcterms:modified>
</cp:coreProperties>
</file>